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30"/>
    <p:restoredTop sz="94737"/>
  </p:normalViewPr>
  <p:slideViewPr>
    <p:cSldViewPr snapToGrid="0">
      <p:cViewPr varScale="1">
        <p:scale>
          <a:sx n="144" d="100"/>
          <a:sy n="144" d="100"/>
        </p:scale>
        <p:origin x="2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F0D8C2-5C11-0B36-4BE4-CD819A67DC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CEA4ED-6387-BA66-B75A-1B413F8744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B5F35-4467-CCD4-1F42-476AEE680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CCEC6C-5B8F-F571-0535-274339BE3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D0F99A-6BC9-D343-3E97-032AB68E8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346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62B3B2-534D-2823-27A5-78BB616C6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466746-1A00-CBDF-4946-4DF8EDA433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A53A18-0B37-E19A-B4A0-9149E40DE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1B0C69-6359-DEAA-5AF1-E42AB4F21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F69235-506F-2327-DFF5-B2E384A3B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587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5CB41C-DF4B-020E-E247-3D6283C8B0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36BA4A-E678-D280-A612-EE9E512942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34F3D-AE1A-8CA1-8F2A-3B10A8E43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155AC2-9D22-95EB-9D02-6EC785938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1D5246-5468-1C6B-8E1F-BCDF59E89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70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8E7A34-F41D-6005-726E-1515CC715C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85EE52-491C-B151-CE89-2AA839994A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D66FBB-0228-20DA-735C-8D6679A10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66E000-3522-109A-2C74-814374E7E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7C5B92-7556-460B-AC26-67B67970B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969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842116-25F7-1885-DB3E-4F43177F6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9D02E6-D2A9-C2BD-0CC7-B2BE937907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C2AED6-945D-B5B9-668A-8F4E809BB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7ED1B4-52BE-B26D-7C46-5DCD11E4D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C9523E-4119-05FD-1A77-99D043EC4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0788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E1E22-E5F8-E032-BB2C-81798C11C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78909-6490-2760-9997-39BED53ACC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A4E3EF-53D4-8501-FB36-DECADF83F5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55F4A4-5284-6A15-CAA1-2577147FB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ACEC19-66A8-F330-DC3A-B8CD0F23A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34FE54-0866-97D9-7073-F5DF15E80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224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8DF01-432B-0781-8AE1-29F5B19F0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B04C82-A92B-AA89-2C39-9FF7B61DD0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E70856-E68A-2EB2-9549-3D98F5F22F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6D8733-4A8A-4BE7-4B0B-92A3C263B8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850A66-BC28-51D6-F094-D26440FFDD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96C934-9F56-39EB-EB17-5D534FF8D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6596BF-304F-D377-6659-BE7C43F20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F9A7F62-5935-1024-1C01-DF7061FE9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1674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6077E-0D25-6D73-9442-BB7425D34E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AADAB3-E8AC-EA1E-FA8F-265ED27F0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E724D9B-1F1A-3055-F484-231CDBB7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4D665D-9ED6-593C-FAFD-C814544EC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348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8B70A0-4C53-45C9-F707-50EEF8661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62D0DA-85E9-1D3B-887E-994F2A383C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518304-F110-284C-F82A-2AE975CE74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469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99B23-B18B-DA31-44A8-CA2CE9A50B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5CA658-190F-121D-8A2C-8931676F54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4153F8-50EF-C44B-3A72-526E82AF86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3959E9-0D87-EA64-A4C1-0E2A44AC4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009204-25DB-2AD6-ACCC-4A91FA5DA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A9B54E-9E10-E910-4E7F-8848EE546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26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A43D4-4801-DF34-0E34-C4DF28CF93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6AC01F-1693-ABE7-CF74-5108DC8133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E242B6-FD1B-2597-7772-893BA79E1E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1A8DE6-B287-1112-0F13-0995D0573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D4E1A3-91D2-9936-1A9B-09208DA90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122FE5-B3C3-A1BF-9E3D-DB239BDD4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322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5863C8-28A7-5527-7205-F1ED29954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1D0705-BD37-7300-E98D-39FCA6CAD9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C65367-CE2F-7538-63CD-6423DB36BA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6785DE-D971-5044-92E7-A830C0744F7A}" type="datetimeFigureOut">
              <a:rPr lang="en-US" smtClean="0"/>
              <a:t>7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1B8F38-D0D0-2137-6CE2-D8A78153DE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38FF02-F83F-9CB2-9B1B-115ABC111E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032800-1479-B748-AFCE-14714CB0A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929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dna molecule&#10;&#10;AI-generated content may be incorrect.">
            <a:extLst>
              <a:ext uri="{FF2B5EF4-FFF2-40B4-BE49-F238E27FC236}">
                <a16:creationId xmlns:a16="http://schemas.microsoft.com/office/drawing/2014/main" id="{358FC709-76F1-D882-B4BF-9AF47BBEE5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687" y="1143000"/>
            <a:ext cx="6400800" cy="4572000"/>
          </a:xfrm>
          <a:prstGeom prst="rect">
            <a:avLst/>
          </a:prstGeom>
        </p:spPr>
      </p:pic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B34CDB0-B9BB-D32E-07E7-77A3D8BB5D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5715981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 3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C17077443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.56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6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2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0E-08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23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.85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63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id="{B65EE602-F2DD-5BB0-E154-9484BB99EB1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7197667" y="1299829"/>
            <a:ext cx="3764121" cy="4070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025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white rectangular object with black lines&#10;&#10;AI-generated content may be incorrect.">
            <a:extLst>
              <a:ext uri="{FF2B5EF4-FFF2-40B4-BE49-F238E27FC236}">
                <a16:creationId xmlns:a16="http://schemas.microsoft.com/office/drawing/2014/main" id="{C4990CC3-295E-D6AD-5BC0-239972AF86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730" y="1143000"/>
            <a:ext cx="6400800" cy="4572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75CBFCE-5497-C912-744B-FC5E65C712A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7482210" y="1399553"/>
            <a:ext cx="3872329" cy="4187041"/>
          </a:xfrm>
          <a:prstGeom prst="rect">
            <a:avLst/>
          </a:prstGeom>
        </p:spPr>
      </p:pic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3620B423-DB59-071E-E6B0-BEB6DF0F01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0944133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ervical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UNC1623801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1.92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8.35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81.4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04E-275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1.9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2.4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622807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B9FD367-84B8-709E-C87A-4413AB7D6C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0234759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ervical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UNC1740518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.9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0.7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93.2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91E-28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.9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6.47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  <p:pic>
        <p:nvPicPr>
          <p:cNvPr id="4" name="Picture 3" descr="A diagram of dna testing&#10;&#10;AI-generated content may be incorrect.">
            <a:extLst>
              <a:ext uri="{FF2B5EF4-FFF2-40B4-BE49-F238E27FC236}">
                <a16:creationId xmlns:a16="http://schemas.microsoft.com/office/drawing/2014/main" id="{A8E091D3-EA60-6FF0-1323-C51FE16010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833" y="1498107"/>
            <a:ext cx="6400800" cy="4572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EE4CD71-40FD-94F7-A0AA-5201E86DBAC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7362979" y="1700947"/>
            <a:ext cx="3742986" cy="3990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7271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D57C08E-F164-B700-F928-D8489B6E2C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2981898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ervical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UNC2376509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9.1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7.0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90.8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.33E-28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5.7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7.2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  <p:pic>
        <p:nvPicPr>
          <p:cNvPr id="4" name="Picture 3" descr="A diagram of dna sequence&#10;&#10;AI-generated content may be incorrect.">
            <a:extLst>
              <a:ext uri="{FF2B5EF4-FFF2-40B4-BE49-F238E27FC236}">
                <a16:creationId xmlns:a16="http://schemas.microsoft.com/office/drawing/2014/main" id="{3D9BBB69-BDC4-943E-9914-85D328EDA7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833" y="1498107"/>
            <a:ext cx="6400800" cy="4572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D920924-7B44-CBD5-7F48-BA9D1B2CD8E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7235301" y="1691695"/>
            <a:ext cx="3542190" cy="37766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7204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B487B38-4990-D796-BC3C-E46DC97BC3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8980270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Cervical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UNC2640245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6.96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6.5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77.7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5.25E-27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0.00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2.8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7.34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  <p:pic>
        <p:nvPicPr>
          <p:cNvPr id="4" name="Picture 3" descr="A diagram of dna genotype&#10;&#10;AI-generated content may be incorrect.">
            <a:extLst>
              <a:ext uri="{FF2B5EF4-FFF2-40B4-BE49-F238E27FC236}">
                <a16:creationId xmlns:a16="http://schemas.microsoft.com/office/drawing/2014/main" id="{22D6A3A1-60D7-9FF8-26C8-357629023A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833" y="1578006"/>
            <a:ext cx="6400800" cy="4572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E4C568F-23A7-B8B9-4C14-C05469CF132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7327468" y="1585197"/>
            <a:ext cx="3858395" cy="4113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12533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EC66EE2-58F4-7325-A1DE-A63338C6BF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0991896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umbar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JAX0017104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9.5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3.5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.5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.57E-0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3.3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4.0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9.63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  <p:pic>
        <p:nvPicPr>
          <p:cNvPr id="4" name="Picture 3" descr="A graph showing the number of dna&#10;&#10;AI-generated content may be incorrect.">
            <a:extLst>
              <a:ext uri="{FF2B5EF4-FFF2-40B4-BE49-F238E27FC236}">
                <a16:creationId xmlns:a16="http://schemas.microsoft.com/office/drawing/2014/main" id="{3DF29F78-8F07-A385-03EE-B408473A86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833" y="1692151"/>
            <a:ext cx="7772400" cy="34736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824BE76-7526-F5CC-5E78-3B717C5337D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8240233" y="972649"/>
            <a:ext cx="3567068" cy="380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3385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8A8FE45-BD83-5D34-6328-6FFED48FEB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7575632"/>
              </p:ext>
            </p:extLst>
          </p:nvPr>
        </p:nvGraphicFramePr>
        <p:xfrm>
          <a:off x="467833" y="270083"/>
          <a:ext cx="6767468" cy="56032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31432">
                  <a:extLst>
                    <a:ext uri="{9D8B030D-6E8A-4147-A177-3AD203B41FA5}">
                      <a16:colId xmlns:a16="http://schemas.microsoft.com/office/drawing/2014/main" val="1398176606"/>
                    </a:ext>
                  </a:extLst>
                </a:gridCol>
                <a:gridCol w="1074201">
                  <a:extLst>
                    <a:ext uri="{9D8B030D-6E8A-4147-A177-3AD203B41FA5}">
                      <a16:colId xmlns:a16="http://schemas.microsoft.com/office/drawing/2014/main" val="1679421877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val="2217084440"/>
                    </a:ext>
                  </a:extLst>
                </a:gridCol>
                <a:gridCol w="568610">
                  <a:extLst>
                    <a:ext uri="{9D8B030D-6E8A-4147-A177-3AD203B41FA5}">
                      <a16:colId xmlns:a16="http://schemas.microsoft.com/office/drawing/2014/main" val="4261640187"/>
                    </a:ext>
                  </a:extLst>
                </a:gridCol>
                <a:gridCol w="527791">
                  <a:extLst>
                    <a:ext uri="{9D8B030D-6E8A-4147-A177-3AD203B41FA5}">
                      <a16:colId xmlns:a16="http://schemas.microsoft.com/office/drawing/2014/main" val="2011875421"/>
                    </a:ext>
                  </a:extLst>
                </a:gridCol>
                <a:gridCol w="644521">
                  <a:extLst>
                    <a:ext uri="{9D8B030D-6E8A-4147-A177-3AD203B41FA5}">
                      <a16:colId xmlns:a16="http://schemas.microsoft.com/office/drawing/2014/main" val="996272857"/>
                    </a:ext>
                  </a:extLst>
                </a:gridCol>
                <a:gridCol w="837877">
                  <a:extLst>
                    <a:ext uri="{9D8B030D-6E8A-4147-A177-3AD203B41FA5}">
                      <a16:colId xmlns:a16="http://schemas.microsoft.com/office/drawing/2014/main" val="1527785655"/>
                    </a:ext>
                  </a:extLst>
                </a:gridCol>
                <a:gridCol w="580069">
                  <a:extLst>
                    <a:ext uri="{9D8B030D-6E8A-4147-A177-3AD203B41FA5}">
                      <a16:colId xmlns:a16="http://schemas.microsoft.com/office/drawing/2014/main" val="1594047244"/>
                    </a:ext>
                  </a:extLst>
                </a:gridCol>
                <a:gridCol w="745496">
                  <a:extLst>
                    <a:ext uri="{9D8B030D-6E8A-4147-A177-3AD203B41FA5}">
                      <a16:colId xmlns:a16="http://schemas.microsoft.com/office/drawing/2014/main" val="624299257"/>
                    </a:ext>
                  </a:extLst>
                </a:gridCol>
                <a:gridCol w="543546">
                  <a:extLst>
                    <a:ext uri="{9D8B030D-6E8A-4147-A177-3AD203B41FA5}">
                      <a16:colId xmlns:a16="http://schemas.microsoft.com/office/drawing/2014/main" val="2058365361"/>
                    </a:ext>
                  </a:extLst>
                </a:gridCol>
              </a:tblGrid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sion loc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P I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 (cM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D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Var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xim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tal (Mb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62877622"/>
                  </a:ext>
                </a:extLst>
              </a:tr>
              <a:tr h="20701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b="1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umbar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UNC2902382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4.0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2.6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.9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.13E-08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93.9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3.99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050" kern="100" dirty="0">
                          <a:effectLst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4.0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09495818"/>
                  </a:ext>
                </a:extLst>
              </a:tr>
            </a:tbl>
          </a:graphicData>
        </a:graphic>
      </p:graphicFrame>
      <p:pic>
        <p:nvPicPr>
          <p:cNvPr id="4" name="Picture 3" descr="A graph of dna sequence&#10;&#10;AI-generated content may be incorrect.">
            <a:extLst>
              <a:ext uri="{FF2B5EF4-FFF2-40B4-BE49-F238E27FC236}">
                <a16:creationId xmlns:a16="http://schemas.microsoft.com/office/drawing/2014/main" id="{C56FB5D9-5250-4A99-FEBF-3ACBFB3041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833" y="1927688"/>
            <a:ext cx="7772400" cy="34736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4AD0034-33BC-DA7A-3519-7ECF863578F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8348399" y="1478492"/>
            <a:ext cx="3467779" cy="3697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3463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46</Words>
  <Application>Microsoft Macintosh PowerPoint</Application>
  <PresentationFormat>Widescreen</PresentationFormat>
  <Paragraphs>14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inkmeyer-Langford, Candice L</dc:creator>
  <cp:lastModifiedBy>Brinkmeyer-Langford, Candice L</cp:lastModifiedBy>
  <cp:revision>1</cp:revision>
  <dcterms:created xsi:type="dcterms:W3CDTF">2025-07-16T20:05:26Z</dcterms:created>
  <dcterms:modified xsi:type="dcterms:W3CDTF">2025-07-16T20:30:57Z</dcterms:modified>
</cp:coreProperties>
</file>